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96" d="100"/>
          <a:sy n="96" d="100"/>
        </p:scale>
        <p:origin x="1094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09842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805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1968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7458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6253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4315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0786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079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528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4551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7114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77768-C2CA-4F12-A1FB-20C5F3415DDB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2BFD9B-97EE-4755-AFEA-49113D19B8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911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3018307" y="1744002"/>
            <a:ext cx="2912013" cy="140677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3018307" y="4934740"/>
            <a:ext cx="2912013" cy="140677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3018307" y="4277229"/>
            <a:ext cx="2912013" cy="140677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円/楕円 8"/>
          <p:cNvSpPr/>
          <p:nvPr/>
        </p:nvSpPr>
        <p:spPr>
          <a:xfrm>
            <a:off x="4340670" y="4836266"/>
            <a:ext cx="267286" cy="39389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971612" y="5132757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tion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3018307" y="1075367"/>
            <a:ext cx="2912013" cy="140677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円/楕円 13"/>
          <p:cNvSpPr/>
          <p:nvPr/>
        </p:nvSpPr>
        <p:spPr>
          <a:xfrm>
            <a:off x="4340670" y="934897"/>
            <a:ext cx="267286" cy="39389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971612" y="137467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tion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911176" y="468433"/>
            <a:ext cx="5126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558R(+) +</a:t>
            </a:r>
            <a:r>
              <a: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geneous mutation (</a:t>
            </a:r>
            <a:r>
              <a:rPr lang="en-US" altLang="ja-JP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ele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988668" y="3800309"/>
            <a:ext cx="4971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558R(+) +</a:t>
            </a:r>
            <a:r>
              <a: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geneous mutation </a:t>
            </a:r>
            <a:r>
              <a:rPr lang="en-US" altLang="ja-JP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is allele)</a:t>
            </a:r>
            <a:endParaRPr kumimoji="1" lang="ja-JP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下矢印 17"/>
          <p:cNvSpPr/>
          <p:nvPr/>
        </p:nvSpPr>
        <p:spPr>
          <a:xfrm>
            <a:off x="4145753" y="2036013"/>
            <a:ext cx="657120" cy="411933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下矢印 18"/>
          <p:cNvSpPr/>
          <p:nvPr/>
        </p:nvSpPr>
        <p:spPr>
          <a:xfrm>
            <a:off x="4145753" y="5505027"/>
            <a:ext cx="657120" cy="434566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199222" y="2571414"/>
            <a:ext cx="45501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a heterozygous mutation exists on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ele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Tran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ele),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effect of SCN5Amutation is actualized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560754" y="5934670"/>
            <a:ext cx="449589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 a heterozygous mutation exists on G allele (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allele), effect of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N5A mutation i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ieved by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uced expression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G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ele.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016911" y="4162901"/>
            <a:ext cx="896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allel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010532" y="4816140"/>
            <a:ext cx="909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 allel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016911" y="986387"/>
            <a:ext cx="896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allel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010532" y="1614278"/>
            <a:ext cx="909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llel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0847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72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iko Nakano</dc:creator>
  <cp:lastModifiedBy>hiroya</cp:lastModifiedBy>
  <cp:revision>5</cp:revision>
  <dcterms:created xsi:type="dcterms:W3CDTF">2017-04-02T08:59:42Z</dcterms:created>
  <dcterms:modified xsi:type="dcterms:W3CDTF">2017-05-10T04:47:22Z</dcterms:modified>
</cp:coreProperties>
</file>